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32ED186-B6F8-EFA2-5C1C-4DC072532B7B}" v="1" dt="2023-07-11T05:05:53.256"/>
    <p1510:client id="{5D57CFA5-18D3-E28B-023F-9B335BC4D1E8}" v="3" dt="2023-10-02T15:53:57.09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265BF5-C9DA-494E-8647-653852DF85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CF2AE65-9775-4279-9C31-8D46988B92B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5D43D0-A760-4560-B7C6-8ACBDC2CBA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02837-6EC6-4C39-B3F6-0AFA19AA82E8}" type="datetimeFigureOut">
              <a:rPr lang="en-US" smtClean="0"/>
              <a:t>10/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E8CCF7-D0B3-46F4-AA4F-C99B2D969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4FC848-5E32-4116-90D2-83884DB8AF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2F3B0-3CCA-40BC-9AFF-485FD64E3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044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805DBD-0D9B-4DCD-9470-458F2400D7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A6EF9A-B1A9-4495-B6F4-CBEECD4850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DED010-D587-4330-9485-EFEEE2081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02837-6EC6-4C39-B3F6-0AFA19AA82E8}" type="datetimeFigureOut">
              <a:rPr lang="en-US" smtClean="0"/>
              <a:t>10/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357DCB-CA56-40EA-BF80-D6D46EDAE5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C68165-51A1-434D-9433-2C2D0F837A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2F3B0-3CCA-40BC-9AFF-485FD64E3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038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382D02D-EAFA-4942-992B-E8A274629F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2F5A0D-EE71-4DA2-9465-1EC488001C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E68F91-7204-448B-9368-3DE3B7A2AD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02837-6EC6-4C39-B3F6-0AFA19AA82E8}" type="datetimeFigureOut">
              <a:rPr lang="en-US" smtClean="0"/>
              <a:t>10/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B9521F-D021-457A-A2BB-2AA032964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3330DC-A0E9-4E27-A211-33A8DF47B9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2F3B0-3CCA-40BC-9AFF-485FD64E3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962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10AB9E-F9FF-44F5-A378-126372FBFA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40EC65-B287-411C-AD15-96934EECC8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E20F4E-A8B7-4787-A70C-07A9889E2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02837-6EC6-4C39-B3F6-0AFA19AA82E8}" type="datetimeFigureOut">
              <a:rPr lang="en-US" smtClean="0"/>
              <a:t>10/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339DE0-3A3C-44BE-9585-946E817A45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33DDD0-4842-43B2-ABBD-D8B14BF27B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2F3B0-3CCA-40BC-9AFF-485FD64E3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6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1C7C33-E87A-4AAC-B807-9FC7527668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F6B632-7A2C-4A93-9802-73CE2C047C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3A5006-4B7E-43BE-A89E-E2D8754D9C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02837-6EC6-4C39-B3F6-0AFA19AA82E8}" type="datetimeFigureOut">
              <a:rPr lang="en-US" smtClean="0"/>
              <a:t>10/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87513B-547E-4D5D-ACE6-289139C99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916E02-DD23-472A-8F87-83002C9FAE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2F3B0-3CCA-40BC-9AFF-485FD64E3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364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8BC429-99E4-44FE-8EA8-E780E4219F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9C0267-3663-4686-BE7E-CE7B5285F86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52434C-2C2C-4777-AC2A-304BC52533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F688DB-30D2-43BA-A40B-BDA35CA001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02837-6EC6-4C39-B3F6-0AFA19AA82E8}" type="datetimeFigureOut">
              <a:rPr lang="en-US" smtClean="0"/>
              <a:t>10/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652E0B-7AED-4153-9D35-52C2B3E47B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E7A347-1A41-4FFF-BB89-FB12F6B24D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2F3B0-3CCA-40BC-9AFF-485FD64E3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169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B91FDE-DB2E-4DB1-8746-FD87120016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B3AC30-90E0-4573-B705-BDC56F512C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AD00EC9-1FC3-48C3-8344-622C29F713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56604E-7D8E-4931-B866-D2928BC10D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24D2178-BFE1-4F78-AA6D-9A51200D73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6B13478-FF88-4073-A662-2A0830C79F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02837-6EC6-4C39-B3F6-0AFA19AA82E8}" type="datetimeFigureOut">
              <a:rPr lang="en-US" smtClean="0"/>
              <a:t>10/2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5A3BC10-10F7-451B-88ED-464B42660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87A7D6D-FC69-412D-B1F3-E11804D4E9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2F3B0-3CCA-40BC-9AFF-485FD64E3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770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A828A7-A33B-4C6D-BF1C-4286BA9A02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8B3EBA8-0B93-41D9-A781-678008295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02837-6EC6-4C39-B3F6-0AFA19AA82E8}" type="datetimeFigureOut">
              <a:rPr lang="en-US" smtClean="0"/>
              <a:t>10/2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29BA80D-2929-4584-AAEE-978902595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F524F23-70BB-4506-90F3-9B04682FFC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2F3B0-3CCA-40BC-9AFF-485FD64E3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102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C80243A-4D8F-469E-9CA8-C7D94C2224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02837-6EC6-4C39-B3F6-0AFA19AA82E8}" type="datetimeFigureOut">
              <a:rPr lang="en-US" smtClean="0"/>
              <a:t>10/2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279BB53-8D41-49BA-8B3C-356E7E3D5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823AD18-2ADE-43B6-ACE9-F1AE280DAE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2F3B0-3CCA-40BC-9AFF-485FD64E3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636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4E3A6E-FFCE-45E4-83CC-BD15B5A733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194AE4-2450-4378-BC0C-E4FE01DFBB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A1FCE6-A86A-4992-B62C-92DE299110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406578-74B4-4F17-B3DD-5BE742F8D2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02837-6EC6-4C39-B3F6-0AFA19AA82E8}" type="datetimeFigureOut">
              <a:rPr lang="en-US" smtClean="0"/>
              <a:t>10/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0CF65B-7AAE-4EF2-BD33-4D6F7378CA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A91596-F62C-4402-9C30-77CAD51141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2F3B0-3CCA-40BC-9AFF-485FD64E3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948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1DCF6A-0AA0-4E39-923A-916EDFE92E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D4702B-88F6-4EB3-BB2A-D98AAD26A3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7FC5FC-B56C-4065-BD7E-FF52594AB9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6832F4-C209-47CA-AAEF-F4FFB06288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02837-6EC6-4C39-B3F6-0AFA19AA82E8}" type="datetimeFigureOut">
              <a:rPr lang="en-US" smtClean="0"/>
              <a:t>10/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B299EC-4EFF-4F47-AA93-36C3A6B631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2056E9-A1E0-473E-A495-84606C4BD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2F3B0-3CCA-40BC-9AFF-485FD64E3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407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2C82AA4-F418-483F-B006-33E569A756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960188-E751-4934-8298-D0DE94A36A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FE4315-B969-4AD0-BA59-727C8E12BF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502837-6EC6-4C39-B3F6-0AFA19AA82E8}" type="datetimeFigureOut">
              <a:rPr lang="en-US" smtClean="0"/>
              <a:t>10/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179EA2-AA08-46D2-9970-44E36F7C2C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A6F4E7-D77F-424C-8529-AC7014A7B6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D2F3B0-3CCA-40BC-9AFF-485FD64E3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395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06F50707-66DE-4447-8A45-517499A6038D}"/>
              </a:ext>
            </a:extLst>
          </p:cNvPr>
          <p:cNvGrpSpPr/>
          <p:nvPr/>
        </p:nvGrpSpPr>
        <p:grpSpPr>
          <a:xfrm>
            <a:off x="659442" y="391148"/>
            <a:ext cx="9914972" cy="6437687"/>
            <a:chOff x="659442" y="391148"/>
            <a:chExt cx="9914972" cy="6437687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8C15156-34C1-47D9-9CB0-38DB4796E3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02" t="29410" r="1628" b="56259"/>
            <a:stretch/>
          </p:blipFill>
          <p:spPr>
            <a:xfrm rot="10800000">
              <a:off x="2631848" y="6091712"/>
              <a:ext cx="6519205" cy="737122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3EB977E1-405F-413D-AC31-9642382076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70" t="53356" r="1899" b="32313"/>
            <a:stretch/>
          </p:blipFill>
          <p:spPr>
            <a:xfrm rot="10800000">
              <a:off x="2631869" y="5354591"/>
              <a:ext cx="6522764" cy="73712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2E957E25-7446-4F21-A314-0EDA62A012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5" t="76938" r="2162" b="8730"/>
            <a:stretch/>
          </p:blipFill>
          <p:spPr>
            <a:xfrm rot="10800000">
              <a:off x="2631852" y="4617471"/>
              <a:ext cx="6519205" cy="737120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8371055-89E6-4A0D-A1C2-22EEE108F974}"/>
                </a:ext>
              </a:extLst>
            </p:cNvPr>
            <p:cNvSpPr txBox="1"/>
            <p:nvPr/>
          </p:nvSpPr>
          <p:spPr>
            <a:xfrm>
              <a:off x="1171729" y="4789131"/>
              <a:ext cx="14072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err="1">
                  <a:latin typeface="Arial" panose="020B0604020202020204" pitchFamily="34" charset="0"/>
                  <a:cs typeface="Arial" panose="020B0604020202020204" pitchFamily="34" charset="0"/>
                </a:rPr>
                <a:t>NSm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-Cub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561D210-152C-4BDD-A158-7E610425E7E2}"/>
                </a:ext>
              </a:extLst>
            </p:cNvPr>
            <p:cNvSpPr txBox="1"/>
            <p:nvPr/>
          </p:nvSpPr>
          <p:spPr>
            <a:xfrm>
              <a:off x="1089809" y="5527023"/>
              <a:ext cx="14984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N-Cub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4A48573-C040-4E77-A17F-C03DFB2B72B1}"/>
                </a:ext>
              </a:extLst>
            </p:cNvPr>
            <p:cNvSpPr txBox="1"/>
            <p:nvPr/>
          </p:nvSpPr>
          <p:spPr>
            <a:xfrm>
              <a:off x="1233618" y="6191628"/>
              <a:ext cx="13453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NSs-Cub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43EB61D-FDD2-4EA2-9061-653FCAED1D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65" t="66667" r="2641" b="20272"/>
            <a:stretch/>
          </p:blipFill>
          <p:spPr>
            <a:xfrm>
              <a:off x="2631852" y="2549328"/>
              <a:ext cx="6519207" cy="671804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EAD00FD7-691C-4CF2-AD40-174779B0AF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18" t="42751" r="1689" b="44188"/>
            <a:stretch/>
          </p:blipFill>
          <p:spPr>
            <a:xfrm>
              <a:off x="2631852" y="1877524"/>
              <a:ext cx="6519208" cy="671804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2A931B3C-CFF0-46E7-9C54-399F46EF4F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17" t="19471" r="1688" b="66198"/>
            <a:stretch/>
          </p:blipFill>
          <p:spPr>
            <a:xfrm>
              <a:off x="2631852" y="1140405"/>
              <a:ext cx="6519208" cy="737119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22C7B9F-9B4F-4572-AAC5-918256630B96}"/>
                </a:ext>
              </a:extLst>
            </p:cNvPr>
            <p:cNvSpPr txBox="1"/>
            <p:nvPr/>
          </p:nvSpPr>
          <p:spPr>
            <a:xfrm>
              <a:off x="1089809" y="1285815"/>
              <a:ext cx="14922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baseline="-2500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S-Cub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7E36793-277A-4EC2-A3BC-A9D733DD5E1D}"/>
                </a:ext>
              </a:extLst>
            </p:cNvPr>
            <p:cNvSpPr txBox="1"/>
            <p:nvPr/>
          </p:nvSpPr>
          <p:spPr>
            <a:xfrm>
              <a:off x="659442" y="2061418"/>
              <a:ext cx="19278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baseline="-2500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1353-Cub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4DE5C65-F9AF-4DC3-A61D-748BC1F8CDDF}"/>
                </a:ext>
              </a:extLst>
            </p:cNvPr>
            <p:cNvSpPr txBox="1"/>
            <p:nvPr/>
          </p:nvSpPr>
          <p:spPr>
            <a:xfrm>
              <a:off x="662673" y="2675457"/>
              <a:ext cx="19278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baseline="-2500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1386-Cub</a:t>
              </a:r>
            </a:p>
          </p:txBody>
        </p:sp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E7F6BC15-86E7-4B84-8BD6-DA95C6DA27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14" t="23583" r="309" b="61905"/>
            <a:stretch/>
          </p:blipFill>
          <p:spPr>
            <a:xfrm>
              <a:off x="2631849" y="3211568"/>
              <a:ext cx="6519210" cy="746449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9EFD63A1-55F0-41A5-8E14-8466DC9B22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30" t="65790" r="579" b="21330"/>
            <a:stretch/>
          </p:blipFill>
          <p:spPr>
            <a:xfrm>
              <a:off x="2631047" y="3958017"/>
              <a:ext cx="6520011" cy="662475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025A4C6-E815-45A0-84C2-FC9A4A8C900D}"/>
                </a:ext>
              </a:extLst>
            </p:cNvPr>
            <p:cNvSpPr txBox="1"/>
            <p:nvPr/>
          </p:nvSpPr>
          <p:spPr>
            <a:xfrm>
              <a:off x="1180559" y="3330450"/>
              <a:ext cx="14072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baseline="-2500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S-Cub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4BDCE93-273E-40E2-8FD3-40C8E0F4166D}"/>
                </a:ext>
              </a:extLst>
            </p:cNvPr>
            <p:cNvSpPr txBox="1"/>
            <p:nvPr/>
          </p:nvSpPr>
          <p:spPr>
            <a:xfrm>
              <a:off x="1173033" y="4080012"/>
              <a:ext cx="14072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baseline="-2500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-Cub</a:t>
              </a:r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9B70E71E-258B-4342-A2F6-592CA65EBECB}"/>
                </a:ext>
              </a:extLst>
            </p:cNvPr>
            <p:cNvCxnSpPr>
              <a:cxnSpLocks/>
            </p:cNvCxnSpPr>
            <p:nvPr/>
          </p:nvCxnSpPr>
          <p:spPr>
            <a:xfrm>
              <a:off x="3274422" y="1139711"/>
              <a:ext cx="0" cy="568912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C2896B72-1E74-4CC9-B55B-4EC418DBCDD7}"/>
                </a:ext>
              </a:extLst>
            </p:cNvPr>
            <p:cNvCxnSpPr>
              <a:cxnSpLocks/>
            </p:cNvCxnSpPr>
            <p:nvPr/>
          </p:nvCxnSpPr>
          <p:spPr>
            <a:xfrm>
              <a:off x="3952677" y="1134737"/>
              <a:ext cx="13268" cy="569137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A1879658-CCFA-4374-AB15-DBE7538FDE5C}"/>
                </a:ext>
              </a:extLst>
            </p:cNvPr>
            <p:cNvCxnSpPr>
              <a:cxnSpLocks/>
            </p:cNvCxnSpPr>
            <p:nvPr/>
          </p:nvCxnSpPr>
          <p:spPr>
            <a:xfrm>
              <a:off x="4663843" y="1141529"/>
              <a:ext cx="0" cy="568457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187C0053-F838-470A-B73F-8EBC325846CD}"/>
                </a:ext>
              </a:extLst>
            </p:cNvPr>
            <p:cNvCxnSpPr>
              <a:cxnSpLocks/>
            </p:cNvCxnSpPr>
            <p:nvPr/>
          </p:nvCxnSpPr>
          <p:spPr>
            <a:xfrm>
              <a:off x="5290351" y="1151753"/>
              <a:ext cx="0" cy="567435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D704BE97-8A63-4C03-8230-2BB329666149}"/>
                </a:ext>
              </a:extLst>
            </p:cNvPr>
            <p:cNvCxnSpPr>
              <a:cxnSpLocks/>
            </p:cNvCxnSpPr>
            <p:nvPr/>
          </p:nvCxnSpPr>
          <p:spPr>
            <a:xfrm>
              <a:off x="5957481" y="1151753"/>
              <a:ext cx="0" cy="567435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59370BF2-2413-4160-B873-0CA45FBC28F3}"/>
                </a:ext>
              </a:extLst>
            </p:cNvPr>
            <p:cNvCxnSpPr>
              <a:cxnSpLocks/>
            </p:cNvCxnSpPr>
            <p:nvPr/>
          </p:nvCxnSpPr>
          <p:spPr>
            <a:xfrm>
              <a:off x="6598569" y="1134737"/>
              <a:ext cx="0" cy="569137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6A12BC67-D79E-4B99-A803-95242CDCD94F}"/>
                </a:ext>
              </a:extLst>
            </p:cNvPr>
            <p:cNvCxnSpPr>
              <a:cxnSpLocks/>
            </p:cNvCxnSpPr>
            <p:nvPr/>
          </p:nvCxnSpPr>
          <p:spPr>
            <a:xfrm>
              <a:off x="7196625" y="1153039"/>
              <a:ext cx="0" cy="567306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D5354059-62FE-4328-B54C-BA541FD1CC16}"/>
                </a:ext>
              </a:extLst>
            </p:cNvPr>
            <p:cNvCxnSpPr>
              <a:cxnSpLocks/>
            </p:cNvCxnSpPr>
            <p:nvPr/>
          </p:nvCxnSpPr>
          <p:spPr>
            <a:xfrm>
              <a:off x="7844399" y="1151753"/>
              <a:ext cx="0" cy="567435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8475EE02-7651-4635-AAD7-474E68A1CAF2}"/>
                </a:ext>
              </a:extLst>
            </p:cNvPr>
            <p:cNvCxnSpPr>
              <a:cxnSpLocks/>
            </p:cNvCxnSpPr>
            <p:nvPr/>
          </p:nvCxnSpPr>
          <p:spPr>
            <a:xfrm>
              <a:off x="8495108" y="1151753"/>
              <a:ext cx="0" cy="567435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27D989AE-8E46-40BD-819B-AA9A98B876E2}"/>
                </a:ext>
              </a:extLst>
            </p:cNvPr>
            <p:cNvSpPr txBox="1"/>
            <p:nvPr/>
          </p:nvSpPr>
          <p:spPr>
            <a:xfrm rot="19601753">
              <a:off x="3330545" y="391148"/>
              <a:ext cx="19278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NubG-G</a:t>
              </a:r>
              <a:r>
                <a:rPr lang="en-US" baseline="-2500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1353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95C4585-7C59-432A-83A0-2BF57392B19D}"/>
                </a:ext>
              </a:extLst>
            </p:cNvPr>
            <p:cNvSpPr txBox="1"/>
            <p:nvPr/>
          </p:nvSpPr>
          <p:spPr>
            <a:xfrm rot="19620863">
              <a:off x="3996344" y="392905"/>
              <a:ext cx="19278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NubG-G</a:t>
              </a:r>
              <a:r>
                <a:rPr lang="en-US" baseline="-2500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1386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D3B9DBC3-BEE6-4AC6-AD76-217A8500D694}"/>
                </a:ext>
              </a:extLst>
            </p:cNvPr>
            <p:cNvSpPr txBox="1"/>
            <p:nvPr/>
          </p:nvSpPr>
          <p:spPr>
            <a:xfrm rot="19601753">
              <a:off x="2547281" y="394690"/>
              <a:ext cx="19278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err="1">
                  <a:latin typeface="Arial" panose="020B0604020202020204" pitchFamily="34" charset="0"/>
                  <a:cs typeface="Arial" panose="020B0604020202020204" pitchFamily="34" charset="0"/>
                </a:rPr>
                <a:t>NubG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-G</a:t>
              </a:r>
              <a:r>
                <a:rPr lang="en-US" baseline="-2500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C72819A-1877-41DB-9D95-31B69BD52BD5}"/>
                </a:ext>
              </a:extLst>
            </p:cNvPr>
            <p:cNvSpPr txBox="1"/>
            <p:nvPr/>
          </p:nvSpPr>
          <p:spPr>
            <a:xfrm rot="19535600">
              <a:off x="4640992" y="586684"/>
              <a:ext cx="14072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err="1">
                  <a:latin typeface="Arial" panose="020B0604020202020204" pitchFamily="34" charset="0"/>
                  <a:cs typeface="Arial" panose="020B0604020202020204" pitchFamily="34" charset="0"/>
                </a:rPr>
                <a:t>NubG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-G</a:t>
              </a:r>
              <a:r>
                <a:rPr lang="en-US" baseline="-2500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0BAF2A9-48B2-4781-8D2A-082B5AC12A15}"/>
                </a:ext>
              </a:extLst>
            </p:cNvPr>
            <p:cNvSpPr txBox="1"/>
            <p:nvPr/>
          </p:nvSpPr>
          <p:spPr>
            <a:xfrm rot="19534748">
              <a:off x="5122295" y="685387"/>
              <a:ext cx="14072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err="1">
                  <a:latin typeface="Arial" panose="020B0604020202020204" pitchFamily="34" charset="0"/>
                  <a:cs typeface="Arial" panose="020B0604020202020204" pitchFamily="34" charset="0"/>
                </a:rPr>
                <a:t>NubG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-G</a:t>
              </a:r>
              <a:r>
                <a:rPr lang="en-US" baseline="-2500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A007BB1B-F4E0-492A-AF1C-85AB582B29E4}"/>
                </a:ext>
              </a:extLst>
            </p:cNvPr>
            <p:cNvSpPr txBox="1"/>
            <p:nvPr/>
          </p:nvSpPr>
          <p:spPr>
            <a:xfrm rot="19430350">
              <a:off x="5983753" y="512976"/>
              <a:ext cx="14072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err="1">
                  <a:latin typeface="Arial" panose="020B0604020202020204" pitchFamily="34" charset="0"/>
                  <a:cs typeface="Arial" panose="020B0604020202020204" pitchFamily="34" charset="0"/>
                </a:rPr>
                <a:t>NubG-NSm</a:t>
              </a:r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E992A86-5A7D-49B6-8FF8-9F5366055146}"/>
                </a:ext>
              </a:extLst>
            </p:cNvPr>
            <p:cNvSpPr txBox="1"/>
            <p:nvPr/>
          </p:nvSpPr>
          <p:spPr>
            <a:xfrm rot="19442348">
              <a:off x="6604050" y="497730"/>
              <a:ext cx="14984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err="1">
                  <a:latin typeface="Arial" panose="020B0604020202020204" pitchFamily="34" charset="0"/>
                  <a:cs typeface="Arial" panose="020B0604020202020204" pitchFamily="34" charset="0"/>
                </a:rPr>
                <a:t>NubG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-N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A935AEE8-59C7-4681-999E-300FDD5D3D81}"/>
                </a:ext>
              </a:extLst>
            </p:cNvPr>
            <p:cNvSpPr txBox="1"/>
            <p:nvPr/>
          </p:nvSpPr>
          <p:spPr>
            <a:xfrm rot="19528760">
              <a:off x="7239722" y="548183"/>
              <a:ext cx="13453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err="1">
                  <a:latin typeface="Arial" panose="020B0604020202020204" pitchFamily="34" charset="0"/>
                  <a:cs typeface="Arial" panose="020B0604020202020204" pitchFamily="34" charset="0"/>
                </a:rPr>
                <a:t>NubG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-NSs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737D2F1B-86EF-443B-B927-FC8BFF17FC5D}"/>
                </a:ext>
              </a:extLst>
            </p:cNvPr>
            <p:cNvSpPr txBox="1"/>
            <p:nvPr/>
          </p:nvSpPr>
          <p:spPr>
            <a:xfrm rot="19320827">
              <a:off x="7899195" y="417220"/>
              <a:ext cx="165125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err="1">
                  <a:latin typeface="Arial" panose="020B0604020202020204" pitchFamily="34" charset="0"/>
                  <a:cs typeface="Arial" panose="020B0604020202020204" pitchFamily="34" charset="0"/>
                </a:rPr>
                <a:t>NubI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 (positive control)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D2D6497F-9A78-41E7-9B6E-1CC820D1C824}"/>
                </a:ext>
              </a:extLst>
            </p:cNvPr>
            <p:cNvSpPr txBox="1"/>
            <p:nvPr/>
          </p:nvSpPr>
          <p:spPr>
            <a:xfrm rot="19351590">
              <a:off x="8762283" y="397045"/>
              <a:ext cx="1812131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err="1">
                  <a:latin typeface="Arial" panose="020B0604020202020204" pitchFamily="34" charset="0"/>
                  <a:cs typeface="Arial" panose="020B0604020202020204" pitchFamily="34" charset="0"/>
                </a:rPr>
                <a:t>NubG</a:t>
              </a:r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 (negative control)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A27462B6-BF64-4619-845E-A26D4A110CB1}"/>
              </a:ext>
            </a:extLst>
          </p:cNvPr>
          <p:cNvSpPr txBox="1"/>
          <p:nvPr/>
        </p:nvSpPr>
        <p:spPr>
          <a:xfrm>
            <a:off x="98323" y="133373"/>
            <a:ext cx="136668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endParaRPr lang="en-US" dirty="0">
              <a:ea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6590377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</Words>
  <Application>Microsoft Macintosh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VVI-Yuting</dc:creator>
  <cp:lastModifiedBy>Kathleen Martin</cp:lastModifiedBy>
  <cp:revision>5</cp:revision>
  <dcterms:created xsi:type="dcterms:W3CDTF">2020-01-03T20:08:21Z</dcterms:created>
  <dcterms:modified xsi:type="dcterms:W3CDTF">2023-10-02T16:19:34Z</dcterms:modified>
</cp:coreProperties>
</file>